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5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17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524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521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60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758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35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115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6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855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56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561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C1C9B-D7C7-49E5-BB49-519F2CA7E0F2}" type="datetimeFigureOut">
              <a:rPr lang="en-US" smtClean="0"/>
              <a:t>5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8B077-A021-41EC-83FC-3280294D0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98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6E8782-7E60-C555-24D6-19A057BD0E6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28913" y="1294458"/>
            <a:ext cx="5898888" cy="36819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E70137C-D987-D773-E084-AB374ED808BD}"/>
              </a:ext>
            </a:extLst>
          </p:cNvPr>
          <p:cNvSpPr txBox="1"/>
          <p:nvPr/>
        </p:nvSpPr>
        <p:spPr>
          <a:xfrm>
            <a:off x="448408" y="483577"/>
            <a:ext cx="3611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6B BNPage proband 4 (S346F)</a:t>
            </a:r>
          </a:p>
        </p:txBody>
      </p:sp>
    </p:spTree>
    <p:extLst>
      <p:ext uri="{BB962C8B-B14F-4D97-AF65-F5344CB8AC3E}">
        <p14:creationId xmlns:p14="http://schemas.microsoft.com/office/powerpoint/2010/main" val="24263383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6911" y="2183027"/>
            <a:ext cx="9822198" cy="409678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98939" y="208861"/>
            <a:ext cx="1243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39884" y="1813695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950076" y="1813695"/>
            <a:ext cx="11716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4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753E8E0-72AB-21BE-72E9-E41060E5C9A7}"/>
              </a:ext>
            </a:extLst>
          </p:cNvPr>
          <p:cNvSpPr/>
          <p:nvPr/>
        </p:nvSpPr>
        <p:spPr>
          <a:xfrm>
            <a:off x="3824654" y="2919046"/>
            <a:ext cx="3420208" cy="11186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27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0679" y="2100649"/>
            <a:ext cx="10008489" cy="44175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55145"/>
            <a:ext cx="1660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852747" y="1731317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612325" y="1695431"/>
            <a:ext cx="1243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4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4EA20EE-5DBA-A9D9-FF0A-B6E579F358AF}"/>
              </a:ext>
            </a:extLst>
          </p:cNvPr>
          <p:cNvSpPr/>
          <p:nvPr/>
        </p:nvSpPr>
        <p:spPr>
          <a:xfrm>
            <a:off x="3525716" y="2663366"/>
            <a:ext cx="3420208" cy="111869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5714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7421" y="1331627"/>
            <a:ext cx="9143487" cy="541516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717060" y="962294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474044" y="962294"/>
            <a:ext cx="12439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4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D415739-2CFD-355C-6FBF-77BDCF920EC4}"/>
              </a:ext>
            </a:extLst>
          </p:cNvPr>
          <p:cNvSpPr/>
          <p:nvPr/>
        </p:nvSpPr>
        <p:spPr>
          <a:xfrm>
            <a:off x="3508131" y="1503484"/>
            <a:ext cx="3420208" cy="385103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ED27516-D05C-7968-B0D9-CC9D4E7CBE34}"/>
              </a:ext>
            </a:extLst>
          </p:cNvPr>
          <p:cNvSpPr txBox="1"/>
          <p:nvPr/>
        </p:nvSpPr>
        <p:spPr>
          <a:xfrm>
            <a:off x="96715" y="111211"/>
            <a:ext cx="168152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omplex 4</a:t>
            </a:r>
          </a:p>
        </p:txBody>
      </p:sp>
    </p:spTree>
    <p:extLst>
      <p:ext uri="{BB962C8B-B14F-4D97-AF65-F5344CB8AC3E}">
        <p14:creationId xmlns:p14="http://schemas.microsoft.com/office/powerpoint/2010/main" val="30651423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7096" y="1255366"/>
            <a:ext cx="9665043" cy="553454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-175846" y="68091"/>
            <a:ext cx="1774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mplex 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408379" y="886034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126847" y="886034"/>
            <a:ext cx="12439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band 4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07180F4-3494-0CED-F93C-DA59EBEC30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1599" y="1346786"/>
            <a:ext cx="3444539" cy="38651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346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8</Words>
  <Application>Microsoft Office PowerPoint</Application>
  <PresentationFormat>Widescreen</PresentationFormat>
  <Paragraphs>1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hildren's Hospital Colorad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se, Tonia</dc:creator>
  <cp:lastModifiedBy>Friederich, Marisa</cp:lastModifiedBy>
  <cp:revision>17</cp:revision>
  <dcterms:created xsi:type="dcterms:W3CDTF">2024-09-05T16:18:17Z</dcterms:created>
  <dcterms:modified xsi:type="dcterms:W3CDTF">2025-05-05T23:10:47Z</dcterms:modified>
</cp:coreProperties>
</file>